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enthil-Kumar Muthappa" initials="SM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8413" autoAdjust="0"/>
  </p:normalViewPr>
  <p:slideViewPr>
    <p:cSldViewPr>
      <p:cViewPr>
        <p:scale>
          <a:sx n="125" d="100"/>
          <a:sy n="125" d="100"/>
        </p:scale>
        <p:origin x="-960" y="10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2507776805677"/>
          <c:y val="0.0384615384615385"/>
          <c:w val="0.568791921843103"/>
          <c:h val="0.831111447607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7</c:f>
              <c:strCache>
                <c:ptCount val="1"/>
                <c:pt idx="0">
                  <c:v>Pathogen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(Sheet1!$G$7,Sheet1!$M$7,Sheet1!$S$7)</c:f>
                <c:numCache>
                  <c:formatCode>General</c:formatCode>
                  <c:ptCount val="3"/>
                  <c:pt idx="0">
                    <c:v>0.272165526975909</c:v>
                  </c:pt>
                  <c:pt idx="1">
                    <c:v>0.272165526975909</c:v>
                  </c:pt>
                  <c:pt idx="2">
                    <c:v>0.272165526975909</c:v>
                  </c:pt>
                </c:numCache>
              </c:numRef>
            </c:plus>
            <c:minus>
              <c:numRef>
                <c:f>(Sheet1!$G$7,Sheet1!$M$7,Sheet1!$S$7)</c:f>
                <c:numCache>
                  <c:formatCode>General</c:formatCode>
                  <c:ptCount val="3"/>
                  <c:pt idx="0">
                    <c:v>0.272165526975909</c:v>
                  </c:pt>
                  <c:pt idx="1">
                    <c:v>0.272165526975909</c:v>
                  </c:pt>
                  <c:pt idx="2">
                    <c:v>0.272165526975909</c:v>
                  </c:pt>
                </c:numCache>
              </c:numRef>
            </c:minus>
          </c:errBars>
          <c:cat>
            <c:strRef>
              <c:f>(Sheet1!$E$6,Sheet1!$K$6,Sheet1!$Q$6)</c:f>
              <c:strCache>
                <c:ptCount val="3"/>
                <c:pt idx="0">
                  <c:v>KBSH53</c:v>
                </c:pt>
                <c:pt idx="1">
                  <c:v>Moden</c:v>
                </c:pt>
                <c:pt idx="2">
                  <c:v>KBSH42</c:v>
                </c:pt>
              </c:strCache>
            </c:strRef>
          </c:cat>
          <c:val>
            <c:numRef>
              <c:f>(Sheet1!$E$7,Sheet1!$K$7,Sheet1!$Q$7)</c:f>
              <c:numCache>
                <c:formatCode>General</c:formatCode>
                <c:ptCount val="3"/>
                <c:pt idx="0">
                  <c:v>5.333333333333332</c:v>
                </c:pt>
                <c:pt idx="1">
                  <c:v>6.333333333333332</c:v>
                </c:pt>
                <c:pt idx="2">
                  <c:v>8.666666666666665</c:v>
                </c:pt>
              </c:numCache>
            </c:numRef>
          </c:val>
        </c:ser>
        <c:ser>
          <c:idx val="1"/>
          <c:order val="1"/>
          <c:tx>
            <c:strRef>
              <c:f>Sheet1!$A$8</c:f>
              <c:strCache>
                <c:ptCount val="1"/>
                <c:pt idx="0">
                  <c:v>Drought+pathogen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(Sheet1!$G$8,Sheet1!$M$8,Sheet1!$S$8)</c:f>
                <c:numCache>
                  <c:formatCode>General</c:formatCode>
                  <c:ptCount val="3"/>
                  <c:pt idx="0">
                    <c:v>0.272165526975909</c:v>
                  </c:pt>
                  <c:pt idx="1">
                    <c:v>0.272165526975909</c:v>
                  </c:pt>
                  <c:pt idx="2">
                    <c:v>0.272165526975909</c:v>
                  </c:pt>
                </c:numCache>
              </c:numRef>
            </c:plus>
            <c:minus>
              <c:numRef>
                <c:f>(Sheet1!$G$8,Sheet1!$M$8,Sheet1!$S$8)</c:f>
                <c:numCache>
                  <c:formatCode>General</c:formatCode>
                  <c:ptCount val="3"/>
                  <c:pt idx="0">
                    <c:v>0.272165526975909</c:v>
                  </c:pt>
                  <c:pt idx="1">
                    <c:v>0.272165526975909</c:v>
                  </c:pt>
                  <c:pt idx="2">
                    <c:v>0.272165526975909</c:v>
                  </c:pt>
                </c:numCache>
              </c:numRef>
            </c:minus>
          </c:errBars>
          <c:cat>
            <c:strRef>
              <c:f>(Sheet1!$E$6,Sheet1!$K$6,Sheet1!$Q$6)</c:f>
              <c:strCache>
                <c:ptCount val="3"/>
                <c:pt idx="0">
                  <c:v>KBSH53</c:v>
                </c:pt>
                <c:pt idx="1">
                  <c:v>Moden</c:v>
                </c:pt>
                <c:pt idx="2">
                  <c:v>KBSH42</c:v>
                </c:pt>
              </c:strCache>
            </c:strRef>
          </c:cat>
          <c:val>
            <c:numRef>
              <c:f>(Sheet1!$E$8,Sheet1!$K$8,Sheet1!$Q$8)</c:f>
              <c:numCache>
                <c:formatCode>General</c:formatCode>
                <c:ptCount val="3"/>
                <c:pt idx="0">
                  <c:v>6.333333333333332</c:v>
                </c:pt>
                <c:pt idx="1">
                  <c:v>7.333333333333332</c:v>
                </c:pt>
                <c:pt idx="2">
                  <c:v>8.666666666666665</c:v>
                </c:pt>
              </c:numCache>
            </c:numRef>
          </c:val>
        </c:ser>
        <c:ser>
          <c:idx val="2"/>
          <c:order val="2"/>
          <c:tx>
            <c:strRef>
              <c:f>Sheet1!$A$9</c:f>
              <c:strCache>
                <c:ptCount val="1"/>
                <c:pt idx="0">
                  <c:v>All combined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(Sheet1!$G$9,Sheet1!$M$9,Sheet1!$S$9)</c:f>
                <c:numCache>
                  <c:formatCode>General</c:formatCode>
                  <c:ptCount val="3"/>
                  <c:pt idx="0">
                    <c:v>0.272165526975909</c:v>
                  </c:pt>
                  <c:pt idx="1">
                    <c:v>0.471404520791032</c:v>
                  </c:pt>
                  <c:pt idx="2">
                    <c:v>0.136082763487954</c:v>
                  </c:pt>
                </c:numCache>
              </c:numRef>
            </c:plus>
            <c:minus>
              <c:numRef>
                <c:f>(Sheet1!$G$9,Sheet1!$M$9,Sheet1!$S$9)</c:f>
                <c:numCache>
                  <c:formatCode>General</c:formatCode>
                  <c:ptCount val="3"/>
                  <c:pt idx="0">
                    <c:v>0.272165526975909</c:v>
                  </c:pt>
                  <c:pt idx="1">
                    <c:v>0.471404520791032</c:v>
                  </c:pt>
                  <c:pt idx="2">
                    <c:v>0.136082763487954</c:v>
                  </c:pt>
                </c:numCache>
              </c:numRef>
            </c:minus>
          </c:errBars>
          <c:cat>
            <c:strRef>
              <c:f>(Sheet1!$E$6,Sheet1!$K$6,Sheet1!$Q$6)</c:f>
              <c:strCache>
                <c:ptCount val="3"/>
                <c:pt idx="0">
                  <c:v>KBSH53</c:v>
                </c:pt>
                <c:pt idx="1">
                  <c:v>Moden</c:v>
                </c:pt>
                <c:pt idx="2">
                  <c:v>KBSH42</c:v>
                </c:pt>
              </c:strCache>
            </c:strRef>
          </c:cat>
          <c:val>
            <c:numRef>
              <c:f>(Sheet1!$E$9,Sheet1!$K$9,Sheet1!$Q$9)</c:f>
              <c:numCache>
                <c:formatCode>General</c:formatCode>
                <c:ptCount val="3"/>
                <c:pt idx="0">
                  <c:v>6.666666666666667</c:v>
                </c:pt>
                <c:pt idx="1">
                  <c:v>7.0</c:v>
                </c:pt>
                <c:pt idx="2">
                  <c:v>8.8333333333333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4229592"/>
        <c:axId val="-2111829672"/>
      </c:barChart>
      <c:catAx>
        <c:axId val="21242295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111829672"/>
        <c:crosses val="autoZero"/>
        <c:auto val="1"/>
        <c:lblAlgn val="ctr"/>
        <c:lblOffset val="100"/>
        <c:noMultiLvlLbl val="0"/>
      </c:catAx>
      <c:valAx>
        <c:axId val="-21118296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err="1" smtClean="0"/>
                  <a:t>Colour</a:t>
                </a:r>
                <a:r>
                  <a:rPr lang="en-US" baseline="0" dirty="0" smtClean="0"/>
                  <a:t> </a:t>
                </a:r>
                <a:r>
                  <a:rPr lang="en-US" baseline="0" dirty="0"/>
                  <a:t>intensity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24229592"/>
        <c:crosses val="autoZero"/>
        <c:crossBetween val="between"/>
      </c:valAx>
    </c:plotArea>
    <c:legend>
      <c:legendPos val="t"/>
      <c:layout/>
      <c:overlay val="1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74D527-8677-458D-A945-C626A075FFA4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EFCBC5-5A49-491A-B23C-DB83C0BBEA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506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EFCBC5-5A49-491A-B23C-DB83C0BBEA10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114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jpeg"/><Relationship Id="rId5" Type="http://schemas.openxmlformats.org/officeDocument/2006/relationships/image" Target="../media/image3.jpeg"/><Relationship Id="rId6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37429" y="701873"/>
            <a:ext cx="2734571" cy="6289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993917" y="854273"/>
            <a:ext cx="789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itchFamily="34" charset="0"/>
              </a:rPr>
              <a:t>Pathogen 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 cstate="print"/>
          <a:srcRect l="48366" t="6127" r="24837"/>
          <a:stretch>
            <a:fillRect/>
          </a:stretch>
        </p:blipFill>
        <p:spPr bwMode="auto">
          <a:xfrm rot="5400000">
            <a:off x="2861173" y="358277"/>
            <a:ext cx="692008" cy="27567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564281" y="1545507"/>
            <a:ext cx="12449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itchFamily="34" charset="0"/>
              </a:rPr>
              <a:t>Combined drought  and pathogen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916875" y="452500"/>
            <a:ext cx="2476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itchFamily="34" charset="0"/>
              </a:rPr>
              <a:t>KBSH53             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Morde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          KBSH42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5" cstate="print"/>
          <a:srcRect l="15566" t="30189" b="41509"/>
          <a:stretch>
            <a:fillRect/>
          </a:stretch>
        </p:blipFill>
        <p:spPr bwMode="auto">
          <a:xfrm flipH="1">
            <a:off x="1828800" y="2133600"/>
            <a:ext cx="2743200" cy="704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Box 9"/>
          <p:cNvSpPr txBox="1"/>
          <p:nvPr/>
        </p:nvSpPr>
        <p:spPr>
          <a:xfrm>
            <a:off x="183281" y="2144862"/>
            <a:ext cx="162975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itchFamily="18" charset="0"/>
                <a:cs typeface="Arial" pitchFamily="34" charset="0"/>
              </a:rPr>
              <a:t>Combined pathogen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, NaCl, 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drought,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cold and 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methyl </a:t>
            </a:r>
            <a:r>
              <a:rPr lang="en-US" sz="1000" dirty="0" err="1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viologen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stress</a:t>
            </a:r>
            <a:endParaRPr lang="en-US" sz="1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0125" y="5029200"/>
            <a:ext cx="67818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10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eroxide radical quantification by NBT staining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The leaf samples after exposing to stress treatments were collected and stained with 0.1% </a:t>
            </a:r>
            <a:r>
              <a:rPr lang="en-US" sz="1200" dirty="0" err="1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nitroblue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 tetrazolium </a:t>
            </a:r>
            <a:r>
              <a:rPr lang="en-US" sz="12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BT) for 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[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50 </a:t>
            </a:r>
            <a:r>
              <a:rPr lang="en-US" sz="1200" dirty="0" err="1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mM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 sodium phosphate buffer pH 7.5, 0.2% nitro blue tetrazolium (Jabs et al. 1996)]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chlorophyll was removed by treating in 70% alcohol overnight. </a:t>
            </a:r>
            <a:r>
              <a:rPr lang="en-US" sz="12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When 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the pale yellow NBT reacts with O</a:t>
            </a:r>
            <a:r>
              <a:rPr lang="en-US" sz="1200" baseline="-300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2</a:t>
            </a:r>
            <a:r>
              <a:rPr lang="en-US" sz="1200" baseline="300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.- 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a dark blue insoluble formazan compound is </a:t>
            </a:r>
            <a:r>
              <a:rPr lang="en-US" sz="12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produced. b) I</a:t>
            </a:r>
            <a:r>
              <a:rPr lang="en-US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mage intensity was quantified using image J tool. </a:t>
            </a:r>
            <a:endParaRPr 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2687816" y="465702"/>
            <a:ext cx="0" cy="2463639"/>
          </a:xfrm>
          <a:prstGeom prst="line">
            <a:avLst/>
          </a:prstGeom>
          <a:ln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3636722" y="618102"/>
            <a:ext cx="0" cy="2463639"/>
          </a:xfrm>
          <a:prstGeom prst="line">
            <a:avLst/>
          </a:prstGeom>
          <a:ln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50125" y="6352401"/>
            <a:ext cx="6655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ference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Jabs T, Dietrich RA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ang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JL. Initiation of runaway cell death in an Arabidopsis mutant by extracellular superoxide. Science. 1996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273:1853–185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4393835" y="1210449"/>
            <a:ext cx="13284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1064138"/>
              </p:ext>
            </p:extLst>
          </p:nvPr>
        </p:nvGraphicFramePr>
        <p:xfrm>
          <a:off x="1219200" y="2971800"/>
          <a:ext cx="41148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381000" y="457200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81000" y="2971800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02787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40</TotalTime>
  <Words>162</Words>
  <Application>Microsoft Macintosh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mu's</dc:creator>
  <cp:lastModifiedBy>Ramu Vemanna</cp:lastModifiedBy>
  <cp:revision>153</cp:revision>
  <dcterms:created xsi:type="dcterms:W3CDTF">2006-08-16T00:00:00Z</dcterms:created>
  <dcterms:modified xsi:type="dcterms:W3CDTF">2016-02-15T03:56:05Z</dcterms:modified>
</cp:coreProperties>
</file>